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00" r:id="rId2"/>
  </p:sldIdLst>
  <p:sldSz cx="6858000" cy="9906000" type="A4"/>
  <p:notesSz cx="9931400" cy="67945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10" userDrawn="1">
          <p15:clr>
            <a:srgbClr val="A4A3A4"/>
          </p15:clr>
        </p15:guide>
        <p15:guide id="2" pos="391" userDrawn="1">
          <p15:clr>
            <a:srgbClr val="A4A3A4"/>
          </p15:clr>
        </p15:guide>
        <p15:guide id="6" orient="horz" pos="6136" userDrawn="1">
          <p15:clr>
            <a:srgbClr val="A4A3A4"/>
          </p15:clr>
        </p15:guide>
        <p15:guide id="7" pos="3884" userDrawn="1">
          <p15:clr>
            <a:srgbClr val="A4A3A4"/>
          </p15:clr>
        </p15:guide>
        <p15:guide id="8" orient="horz" pos="4435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E09670F-CE05-9C7F-2A18-F12607C6DEEE}" name="Eva Herrero Serrano" initials="EHS" userId="S::eh642@cam.ac.uk::30ee73c8-4441-48c1-9b41-6efa0a64ae52" providerId="AD"/>
  <p188:author id="{14A239CE-EE99-779E-A9A8-70BD1B86BCFC}" name="Alex Webb" initials="AW" userId="S::aarw2@cam.ac.uk::6e034127-e0df-4368-bc35-fbdfd215004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D92"/>
    <a:srgbClr val="163E62"/>
    <a:srgbClr val="4C95D9"/>
    <a:srgbClr val="46B1E1"/>
    <a:srgbClr val="7A81FF"/>
    <a:srgbClr val="0432FF"/>
    <a:srgbClr val="163E63"/>
    <a:srgbClr val="FF8AD8"/>
    <a:srgbClr val="ECECEC"/>
    <a:srgbClr val="4D95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80" d="100"/>
          <a:sy n="80" d="100"/>
        </p:scale>
        <p:origin x="3576" y="192"/>
      </p:cViewPr>
      <p:guideLst>
        <p:guide orient="horz" pos="1510"/>
        <p:guide pos="391"/>
        <p:guide orient="horz" pos="6136"/>
        <p:guide pos="3884"/>
        <p:guide orient="horz" pos="44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5497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0B9EA6-4523-204F-A38C-EB310BB9E6E6}" type="datetimeFigureOut">
              <a:rPr lang="en-US" smtClean="0"/>
              <a:t>7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71950" y="849313"/>
            <a:ext cx="1587500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3140" y="3269853"/>
            <a:ext cx="7945120" cy="2675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5497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65B47-02A3-6545-81BD-CE096AC3AC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9780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65B47-02A3-6545-81BD-CE096AC3AC5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6243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0749-87E1-654D-9347-98A262523D99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366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A369A-2B05-6844-B0A9-E549CABD4D18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881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2C1AE-F068-A54F-BD59-F157D26CAF3B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038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A49AF-D4B1-B841-A3C6-0797BAE97B73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735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EC4B1-A988-4D40-8895-309A5922874F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504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28266-E031-EE4A-AA5B-25E86C1B8835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672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81142-A245-CD4C-98EC-FE91F66445E5}" type="datetime1">
              <a:rPr lang="en-GB" smtClean="0"/>
              <a:t>02/0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482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AF423-F805-2041-97CC-1A4994037567}" type="datetime1">
              <a:rPr lang="en-GB" smtClean="0"/>
              <a:t>02/0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45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91740-F340-7F42-A214-B550E62E5598}" type="datetime1">
              <a:rPr lang="en-GB" smtClean="0"/>
              <a:t>02/0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52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1EBA1-5261-ED4A-BA40-688502E8C4F1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586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8212F-31D4-CC4E-BBE9-0FE5E46009E3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961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6F5EBD4-D993-2F4A-BC64-32375B140610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563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10" Type="http://schemas.openxmlformats.org/officeDocument/2006/relationships/image" Target="../media/image8.svg"/><Relationship Id="rId4" Type="http://schemas.openxmlformats.org/officeDocument/2006/relationships/image" Target="../media/image2.sv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3F8E60F-1DBF-2EC5-6D76-76CBF7B165B3}"/>
              </a:ext>
            </a:extLst>
          </p:cNvPr>
          <p:cNvSpPr txBox="1"/>
          <p:nvPr/>
        </p:nvSpPr>
        <p:spPr>
          <a:xfrm>
            <a:off x="127455" y="422058"/>
            <a:ext cx="66030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Extended data Figure 8. </a:t>
            </a:r>
            <a:r>
              <a:rPr lang="en-US" i="1"/>
              <a:t>ttg1 lwd1 lwd2</a:t>
            </a:r>
            <a:r>
              <a:rPr lang="en-US"/>
              <a:t> mutants recapitulate some </a:t>
            </a:r>
            <a:r>
              <a:rPr lang="en-US" i="1"/>
              <a:t>PIF4-OX</a:t>
            </a:r>
            <a:r>
              <a:rPr lang="en-US"/>
              <a:t> phenotypes</a:t>
            </a:r>
            <a:endParaRPr lang="en-US" i="1"/>
          </a:p>
        </p:txBody>
      </p:sp>
      <p:pic>
        <p:nvPicPr>
          <p:cNvPr id="4" name="Graphic 3">
            <a:extLst>
              <a:ext uri="{FF2B5EF4-FFF2-40B4-BE49-F238E27FC236}">
                <a16:creationId xmlns:a16="http://schemas.microsoft.com/office/drawing/2014/main" id="{8821D44C-A16A-227C-DD72-C87BC69888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48349" y="960401"/>
            <a:ext cx="5760000" cy="19753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BE27471-4879-F77F-09CA-DE471127355E}"/>
              </a:ext>
            </a:extLst>
          </p:cNvPr>
          <p:cNvSpPr txBox="1"/>
          <p:nvPr/>
        </p:nvSpPr>
        <p:spPr>
          <a:xfrm>
            <a:off x="441833" y="727391"/>
            <a:ext cx="415636" cy="338554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5D1307C-9E47-B221-F0EF-BE8F7CDA9182}"/>
              </a:ext>
            </a:extLst>
          </p:cNvPr>
          <p:cNvSpPr txBox="1"/>
          <p:nvPr/>
        </p:nvSpPr>
        <p:spPr>
          <a:xfrm>
            <a:off x="441833" y="3047458"/>
            <a:ext cx="415636" cy="338554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A6D3D4-3253-FCAF-986C-48202B8B6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9126312"/>
            <a:ext cx="1543050" cy="527403"/>
          </a:xfrm>
        </p:spPr>
        <p:txBody>
          <a:bodyPr/>
          <a:lstStyle/>
          <a:p>
            <a:r>
              <a:rPr lang="en-US"/>
              <a:t> </a:t>
            </a:r>
            <a:fld id="{81DCAC0E-2F50-0143-987E-34B90C782813}" type="slidenum">
              <a:rPr lang="en-US" smtClean="0"/>
              <a:t>1</a:t>
            </a:fld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85DF1AD-0587-58FB-03B8-E9A207FE0D77}"/>
              </a:ext>
            </a:extLst>
          </p:cNvPr>
          <p:cNvSpPr txBox="1"/>
          <p:nvPr/>
        </p:nvSpPr>
        <p:spPr>
          <a:xfrm>
            <a:off x="430896" y="5551323"/>
            <a:ext cx="415636" cy="338554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11B6B5F-7A6C-FF82-8E49-250B4063E3B4}"/>
              </a:ext>
            </a:extLst>
          </p:cNvPr>
          <p:cNvGrpSpPr/>
          <p:nvPr/>
        </p:nvGrpSpPr>
        <p:grpSpPr>
          <a:xfrm>
            <a:off x="430896" y="3479925"/>
            <a:ext cx="2895600" cy="1761066"/>
            <a:chOff x="418851" y="3341414"/>
            <a:chExt cx="2895600" cy="1761066"/>
          </a:xfrm>
        </p:grpSpPr>
        <p:pic>
          <p:nvPicPr>
            <p:cNvPr id="10" name="Graphic 9">
              <a:extLst>
                <a:ext uri="{FF2B5EF4-FFF2-40B4-BE49-F238E27FC236}">
                  <a16:creationId xmlns:a16="http://schemas.microsoft.com/office/drawing/2014/main" id="{A8CC107B-4D78-DC7B-63D0-EC4EA1B8602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rcRect l="14815" t="43944" r="42963" b="16696"/>
            <a:stretch/>
          </p:blipFill>
          <p:spPr>
            <a:xfrm>
              <a:off x="418851" y="3341414"/>
              <a:ext cx="2895600" cy="1761066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DD4165E-AE9E-C66B-D9F2-3C570AAC21FB}"/>
                </a:ext>
              </a:extLst>
            </p:cNvPr>
            <p:cNvSpPr txBox="1"/>
            <p:nvPr/>
          </p:nvSpPr>
          <p:spPr>
            <a:xfrm>
              <a:off x="1147418" y="4066425"/>
              <a:ext cx="1376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C298601-1AD3-F594-94BC-52B9926EB30D}"/>
                </a:ext>
              </a:extLst>
            </p:cNvPr>
            <p:cNvSpPr txBox="1"/>
            <p:nvPr/>
          </p:nvSpPr>
          <p:spPr>
            <a:xfrm>
              <a:off x="1501054" y="4031117"/>
              <a:ext cx="1376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7351826-D11F-60E7-1E90-C1FDB1F86C21}"/>
                </a:ext>
              </a:extLst>
            </p:cNvPr>
            <p:cNvSpPr txBox="1"/>
            <p:nvPr/>
          </p:nvSpPr>
          <p:spPr>
            <a:xfrm>
              <a:off x="1859589" y="4052284"/>
              <a:ext cx="1376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6CCE02A-6BF7-5F76-7E94-0299EA326A6D}"/>
                </a:ext>
              </a:extLst>
            </p:cNvPr>
            <p:cNvSpPr txBox="1"/>
            <p:nvPr/>
          </p:nvSpPr>
          <p:spPr>
            <a:xfrm>
              <a:off x="2222161" y="3833578"/>
              <a:ext cx="1376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2B5C46C-F6AF-6A5A-08F6-802FDB2A7BD2}"/>
                </a:ext>
              </a:extLst>
            </p:cNvPr>
            <p:cNvSpPr txBox="1"/>
            <p:nvPr/>
          </p:nvSpPr>
          <p:spPr>
            <a:xfrm>
              <a:off x="2579328" y="3530785"/>
              <a:ext cx="1376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8599D11-BBFF-1AD8-C361-01A7DF17754E}"/>
                </a:ext>
              </a:extLst>
            </p:cNvPr>
            <p:cNvSpPr txBox="1"/>
            <p:nvPr/>
          </p:nvSpPr>
          <p:spPr>
            <a:xfrm>
              <a:off x="2939827" y="3474882"/>
              <a:ext cx="1376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404517DF-6BB9-5ECD-170D-DE1E627FDD20}"/>
              </a:ext>
            </a:extLst>
          </p:cNvPr>
          <p:cNvGrpSpPr/>
          <p:nvPr/>
        </p:nvGrpSpPr>
        <p:grpSpPr>
          <a:xfrm>
            <a:off x="3454099" y="3193600"/>
            <a:ext cx="2642616" cy="2487168"/>
            <a:chOff x="503161" y="2371580"/>
            <a:chExt cx="2642616" cy="2487168"/>
          </a:xfrm>
        </p:grpSpPr>
        <p:pic>
          <p:nvPicPr>
            <p:cNvPr id="18" name="Graphic 17">
              <a:extLst>
                <a:ext uri="{FF2B5EF4-FFF2-40B4-BE49-F238E27FC236}">
                  <a16:creationId xmlns:a16="http://schemas.microsoft.com/office/drawing/2014/main" id="{FD549DB9-422F-4C4A-39F4-379F7B07B92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tretch>
              <a:fillRect/>
            </a:stretch>
          </p:blipFill>
          <p:spPr>
            <a:xfrm>
              <a:off x="503161" y="2371580"/>
              <a:ext cx="2642616" cy="2487168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FC69838-240E-F90B-7B45-C9A9DA4E8305}"/>
                </a:ext>
              </a:extLst>
            </p:cNvPr>
            <p:cNvSpPr txBox="1"/>
            <p:nvPr/>
          </p:nvSpPr>
          <p:spPr>
            <a:xfrm>
              <a:off x="1171494" y="3506581"/>
              <a:ext cx="1343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C9FAF3A-B3FA-72B4-3628-AE2CDD6FD99C}"/>
                </a:ext>
              </a:extLst>
            </p:cNvPr>
            <p:cNvSpPr txBox="1"/>
            <p:nvPr/>
          </p:nvSpPr>
          <p:spPr>
            <a:xfrm>
              <a:off x="1589666" y="3394969"/>
              <a:ext cx="1343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729A171-63ED-71A5-A2CE-E30D6A2B58ED}"/>
                </a:ext>
              </a:extLst>
            </p:cNvPr>
            <p:cNvSpPr txBox="1"/>
            <p:nvPr/>
          </p:nvSpPr>
          <p:spPr>
            <a:xfrm>
              <a:off x="2011746" y="3619434"/>
              <a:ext cx="1343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388FC0C-97B0-2706-3B8B-8438A21D71B4}"/>
                </a:ext>
              </a:extLst>
            </p:cNvPr>
            <p:cNvSpPr txBox="1"/>
            <p:nvPr/>
          </p:nvSpPr>
          <p:spPr>
            <a:xfrm>
              <a:off x="2424607" y="3156998"/>
              <a:ext cx="1343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0C83FB4-7D50-AF8E-6474-2E9352E5978A}"/>
                </a:ext>
              </a:extLst>
            </p:cNvPr>
            <p:cNvSpPr txBox="1"/>
            <p:nvPr/>
          </p:nvSpPr>
          <p:spPr>
            <a:xfrm>
              <a:off x="2835832" y="2787611"/>
              <a:ext cx="1343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F1B0123C-5B12-C630-595A-B2478E2495F6}"/>
              </a:ext>
            </a:extLst>
          </p:cNvPr>
          <p:cNvSpPr txBox="1"/>
          <p:nvPr/>
        </p:nvSpPr>
        <p:spPr>
          <a:xfrm>
            <a:off x="3409304" y="3047458"/>
            <a:ext cx="415636" cy="338554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8" name="Graphic 27">
            <a:extLst>
              <a:ext uri="{FF2B5EF4-FFF2-40B4-BE49-F238E27FC236}">
                <a16:creationId xmlns:a16="http://schemas.microsoft.com/office/drawing/2014/main" id="{E90CC4B4-096A-FF5A-300E-80037918E65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30031" y="5892173"/>
            <a:ext cx="5760000" cy="11389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0616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1</Words>
  <Application>Microsoft Macintosh PowerPoint</Application>
  <PresentationFormat>A4 Paper (210x297 mm)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a Herrero Serrano</dc:creator>
  <cp:lastModifiedBy>Eva Herrero Serrano</cp:lastModifiedBy>
  <cp:revision>2</cp:revision>
  <cp:lastPrinted>2025-07-02T13:25:36Z</cp:lastPrinted>
  <dcterms:created xsi:type="dcterms:W3CDTF">2024-05-20T09:44:22Z</dcterms:created>
  <dcterms:modified xsi:type="dcterms:W3CDTF">2025-07-02T13:29:57Z</dcterms:modified>
</cp:coreProperties>
</file>